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565" r:id="rId2"/>
    <p:sldId id="327" r:id="rId3"/>
    <p:sldId id="324" r:id="rId4"/>
    <p:sldId id="328" r:id="rId5"/>
    <p:sldId id="56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elsicassilly@gmail.com" initials="c" lastIdx="2" clrIdx="0">
    <p:extLst>
      <p:ext uri="{19B8F6BF-5375-455C-9EA6-DF929625EA0E}">
        <p15:presenceInfo xmlns:p15="http://schemas.microsoft.com/office/powerpoint/2012/main" userId="862b5d649a11759c" providerId="Windows Live"/>
      </p:ext>
    </p:extLst>
  </p:cmAuthor>
  <p:cmAuthor id="2" name="Reynolds, Todd B" initials="RTB" lastIdx="1" clrIdx="1">
    <p:extLst>
      <p:ext uri="{19B8F6BF-5375-455C-9EA6-DF929625EA0E}">
        <p15:presenceInfo xmlns:p15="http://schemas.microsoft.com/office/powerpoint/2012/main" userId="S::treynol6@utk.edu::f450530e-ecd1-4e42-8eb8-327def559f3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80160" autoAdjust="0"/>
  </p:normalViewPr>
  <p:slideViewPr>
    <p:cSldViewPr snapToGrid="0">
      <p:cViewPr>
        <p:scale>
          <a:sx n="86" d="100"/>
          <a:sy n="86" d="100"/>
        </p:scale>
        <p:origin x="114" y="-4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5FF159-B883-43BA-A75B-57D2480F529A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8682A9-6990-48D0-807F-546676FD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893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8682A9-6990-48D0-807F-546676FDF97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738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1x mean 800 unit. </a:t>
            </a:r>
            <a:r>
              <a:rPr lang="en-US" b="0" i="0" dirty="0">
                <a:solidFill>
                  <a:srgbClr val="3A3A3A"/>
                </a:solidFill>
                <a:effectLst/>
                <a:latin typeface="Arial" panose="020B0604020202020204" pitchFamily="34" charset="0"/>
              </a:rPr>
              <a:t>One unit is defined as the amount of enzyme that hydrolyzes 1 nmol of </a:t>
            </a:r>
            <a:r>
              <a:rPr lang="en-US" b="0" i="1" dirty="0">
                <a:solidFill>
                  <a:srgbClr val="3A3A3A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b="0" i="0" dirty="0">
                <a:solidFill>
                  <a:srgbClr val="3A3A3A"/>
                </a:solidFill>
                <a:effectLst/>
                <a:latin typeface="Arial" panose="020B0604020202020204" pitchFamily="34" charset="0"/>
              </a:rPr>
              <a:t>-Nitrophenyl Phosphate (50 mM) (NEB #P0757) in 1 minute at 30°C in a total reaction volume of 50 µl. Reaction is 30 min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8682A9-6990-48D0-807F-546676FDF97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5841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A5A014-49FB-4DDE-AF3F-7F584C5FB6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6F5F823-88AD-48F9-9687-8278E937B8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8B77EC-8372-4809-915B-476932ECA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38C4-2503-4138-B35C-9158A37AEEE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5CCB53-2995-4E08-9B31-2F8084367C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D22100-19BB-49AB-825E-A342F6064E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CCBB5-0DE2-4DC3-B52E-AE2807959F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5025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DEC6B7-A53F-410D-AFAD-0C9C41C7ED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B029D6-AC61-4795-8021-DA50B5FC94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5BA6B4-1BA8-44D9-B90B-BAB25755C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38C4-2503-4138-B35C-9158A37AEEE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5E93B3-824B-47DC-922E-C5B60CCE9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0E6158-5E56-40F2-B1A1-4A371AB3B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CCBB5-0DE2-4DC3-B52E-AE2807959F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536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DF73E01-9569-4A75-816D-D71F29E62F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69ED72-5E70-43E5-8F5B-B05773502F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E1BFAA-F879-43FB-B0F0-7913313A3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38C4-2503-4138-B35C-9158A37AEEE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D81E53-E744-47F8-B98D-8CBB844D3D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025121-7F51-4235-B6D6-179836BEB0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CCBB5-0DE2-4DC3-B52E-AE2807959F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551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979EE1-22F2-4825-B3F5-E992AFE79B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5B185C-15ED-44C2-AF01-65CF850A16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AA966E-CC95-4538-8018-766F863BA6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38C4-2503-4138-B35C-9158A37AEEE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257E3B-9D80-4B49-AA69-22457C30B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C49F90-5567-4A9C-A0C4-35ED6CE1CD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CCBB5-0DE2-4DC3-B52E-AE2807959F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39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5639E1-4F36-414D-8FCF-D7A0B15A4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331D07-1C1C-4D84-8DB1-75C335364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9DCE2C-D8C0-4AA9-9665-7236D1D7C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38C4-2503-4138-B35C-9158A37AEEE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4BA045-BE8C-4D06-828A-6F10D4700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EF8E2E-43DD-493D-AC7F-7CC7EE1FF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CCBB5-0DE2-4DC3-B52E-AE2807959F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08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201B6F-6E73-4D72-A90C-E3DFC7B959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0980B6-EB91-43A4-A375-EAE8FA58E6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F7BAC7-158D-4FC6-9ED2-7DFE6BD627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FD717D-4712-453D-AE7B-3ECDB417F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38C4-2503-4138-B35C-9158A37AEEE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563EE5-7170-4D4A-8631-13E0F457A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371A9F-E362-49EF-9AEF-D6CF7BF3FD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CCBB5-0DE2-4DC3-B52E-AE2807959F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708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5DC104-078B-4B5B-AB00-08B53780B2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0F1602-8BFB-49C1-B3BC-F1188B44F8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337FC0-76A0-4189-9AAB-31B8040F52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E6CF696-852E-47C8-A42A-7EBEDC7C5A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EC797A-397D-491E-B927-1B25F91EB7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BCCD65-84CD-4AEF-A51B-89F2C14D89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38C4-2503-4138-B35C-9158A37AEEE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40CA232-F4E5-4472-8BE1-6F24FF4C69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22FD6AB-425C-4B21-A9C0-373C11178C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CCBB5-0DE2-4DC3-B52E-AE2807959F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787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179187-C9BC-45D0-9EE7-45B35FF20F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7C2773D-9E9F-4D4D-A374-F5FAF5419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38C4-2503-4138-B35C-9158A37AEEE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B177802-4A4C-4532-8082-46EA59159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A36223B-4848-4F30-8378-BB765ADA0C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CCBB5-0DE2-4DC3-B52E-AE2807959F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74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FBA784D-6230-44BA-A922-74E97BF0BE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38C4-2503-4138-B35C-9158A37AEEE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257B248-5FE6-41AA-AC82-97A11725B8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A26B26E-360C-43F2-89A3-D3EF2BD259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CCBB5-0DE2-4DC3-B52E-AE2807959F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835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C0F62D-54BB-425E-B33F-534E3D3219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73B747-6A42-4155-AD7C-72A22093CC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12DA09-CA90-4794-A099-302E3B1A45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8077DC-28F7-41B7-816A-84261080D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38C4-2503-4138-B35C-9158A37AEEE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930807-22B4-4F82-B466-1D603757F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E4F423-5CDB-4939-B2C7-48A42171BA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CCBB5-0DE2-4DC3-B52E-AE2807959F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047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D93DC4-7BF3-4B38-A49A-BAC0E933BB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0E8DC88-111E-48F9-9BF9-36544942B1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5CBEB2-4778-4315-B5F9-61BB11D236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FF25BD-0FC5-4CF8-BD2E-671ADE8035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938C4-2503-4138-B35C-9158A37AEEE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C9F0A5-C4C9-4377-9B99-373D178AE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BAF453-D057-4887-B34B-F6E7E5E73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CCBB5-0DE2-4DC3-B52E-AE2807959F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41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E88794D-ECC5-4096-A349-2289E9EF96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CD29AF-64B1-4EA3-B710-21F4A33848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365AC9-BC41-4C54-8721-46E8B8DC22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B938C4-2503-4138-B35C-9158A37AEEE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376CE4-2E60-488A-9A1D-68C9361BF7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B8B3B8-8E1B-4C02-9FE9-CE2919706E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CCBB5-0DE2-4DC3-B52E-AE2807959F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7161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m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mp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FF0AD8-265F-4809-B7C2-E0A69B5494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</a:t>
            </a:r>
            <a:r>
              <a:rPr lang="en-US" sz="2800" u="none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ormalized densitometry values (NDVs)</a:t>
            </a:r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a western blotting for CAPT motif (left) and serine binding motif (right) mutants</a:t>
            </a:r>
          </a:p>
        </p:txBody>
      </p:sp>
      <p:graphicFrame>
        <p:nvGraphicFramePr>
          <p:cNvPr id="17" name="Content Placeholder 16">
            <a:extLst>
              <a:ext uri="{FF2B5EF4-FFF2-40B4-BE49-F238E27FC236}">
                <a16:creationId xmlns:a16="http://schemas.microsoft.com/office/drawing/2014/main" id="{C63B4ED8-84BF-4FFD-8072-4F9DC71DD68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475296068"/>
              </p:ext>
            </p:extLst>
          </p:nvPr>
        </p:nvGraphicFramePr>
        <p:xfrm>
          <a:off x="588818" y="1979397"/>
          <a:ext cx="4814456" cy="3274695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346470">
                  <a:extLst>
                    <a:ext uri="{9D8B030D-6E8A-4147-A177-3AD203B41FA5}">
                      <a16:colId xmlns:a16="http://schemas.microsoft.com/office/drawing/2014/main" val="2012750824"/>
                    </a:ext>
                  </a:extLst>
                </a:gridCol>
                <a:gridCol w="1021648">
                  <a:extLst>
                    <a:ext uri="{9D8B030D-6E8A-4147-A177-3AD203B41FA5}">
                      <a16:colId xmlns:a16="http://schemas.microsoft.com/office/drawing/2014/main" val="2497629147"/>
                    </a:ext>
                  </a:extLst>
                </a:gridCol>
                <a:gridCol w="1099868">
                  <a:extLst>
                    <a:ext uri="{9D8B030D-6E8A-4147-A177-3AD203B41FA5}">
                      <a16:colId xmlns:a16="http://schemas.microsoft.com/office/drawing/2014/main" val="3277499952"/>
                    </a:ext>
                  </a:extLst>
                </a:gridCol>
                <a:gridCol w="1346470">
                  <a:extLst>
                    <a:ext uri="{9D8B030D-6E8A-4147-A177-3AD203B41FA5}">
                      <a16:colId xmlns:a16="http://schemas.microsoft.com/office/drawing/2014/main" val="667425818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ain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V 1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V 2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±  Standard deviation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3159735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1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 ± 0.0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7619656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25A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 ± 0.4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914159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28A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  ± 0.1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0391491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129A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 ± 0.5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4757883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133A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 ± 0.9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0100713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142A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 ± 0.5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989676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46A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 ± 0.3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070021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50A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 ± 0.1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9453194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129P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 ±0.2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3429025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133E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 ± 0.3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43677950"/>
                  </a:ext>
                </a:extLst>
              </a:tr>
            </a:tbl>
          </a:graphicData>
        </a:graphic>
      </p:graphicFrame>
      <p:graphicFrame>
        <p:nvGraphicFramePr>
          <p:cNvPr id="21" name="Table 20">
            <a:extLst>
              <a:ext uri="{FF2B5EF4-FFF2-40B4-BE49-F238E27FC236}">
                <a16:creationId xmlns:a16="http://schemas.microsoft.com/office/drawing/2014/main" id="{876B18F2-956D-4F52-A0A1-0E9C4D4EC8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2945811"/>
              </p:ext>
            </p:extLst>
          </p:nvPr>
        </p:nvGraphicFramePr>
        <p:xfrm>
          <a:off x="5709455" y="1979397"/>
          <a:ext cx="4997336" cy="3274695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370816">
                  <a:extLst>
                    <a:ext uri="{9D8B030D-6E8A-4147-A177-3AD203B41FA5}">
                      <a16:colId xmlns:a16="http://schemas.microsoft.com/office/drawing/2014/main" val="3229435548"/>
                    </a:ext>
                  </a:extLst>
                </a:gridCol>
                <a:gridCol w="1127852">
                  <a:extLst>
                    <a:ext uri="{9D8B030D-6E8A-4147-A177-3AD203B41FA5}">
                      <a16:colId xmlns:a16="http://schemas.microsoft.com/office/drawing/2014/main" val="4260844581"/>
                    </a:ext>
                  </a:extLst>
                </a:gridCol>
                <a:gridCol w="1127852">
                  <a:extLst>
                    <a:ext uri="{9D8B030D-6E8A-4147-A177-3AD203B41FA5}">
                      <a16:colId xmlns:a16="http://schemas.microsoft.com/office/drawing/2014/main" val="4248709776"/>
                    </a:ext>
                  </a:extLst>
                </a:gridCol>
                <a:gridCol w="1370816">
                  <a:extLst>
                    <a:ext uri="{9D8B030D-6E8A-4147-A177-3AD203B41FA5}">
                      <a16:colId xmlns:a16="http://schemas.microsoft.com/office/drawing/2014/main" val="1923601986"/>
                    </a:ext>
                  </a:extLst>
                </a:gridCol>
              </a:tblGrid>
              <a:tr h="4762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ain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V 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V 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±  Standard deviation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180248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 ± 0.0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30923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180A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 ±  0.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115093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181A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 ±  0.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560812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182A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 ± 0.5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9539411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183A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 ±  0.6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58478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184A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 ±  0.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490729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186A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 ±  0.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6082773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187A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 ±  0.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01224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189A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 ±  0.9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6346212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90A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 ±  0.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95352351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CD736AD4-122C-4233-A8E2-5EA0DF064BC6}"/>
              </a:ext>
            </a:extLst>
          </p:cNvPr>
          <p:cNvSpPr txBox="1"/>
          <p:nvPr/>
        </p:nvSpPr>
        <p:spPr>
          <a:xfrm>
            <a:off x="535479" y="5713540"/>
            <a:ext cx="973558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lang="en-US" sz="1600" u="none" strike="noStrike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DV 1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600" u="none" strike="noStrike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DV 2 were measured from</a:t>
            </a:r>
            <a:r>
              <a:rPr lang="en-US" sz="16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wo western blots using Image J. </a:t>
            </a:r>
            <a:r>
              <a:rPr lang="en-US" sz="1600" u="none" strike="noStrike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US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3637369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FF0AD8-265F-4809-B7C2-E0A69B5494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63B1A3-EF3B-48E5-AA6B-CFADE36C65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85257" y="4590664"/>
            <a:ext cx="6092241" cy="1832952"/>
          </a:xfrm>
        </p:spPr>
        <p:txBody>
          <a:bodyPr>
            <a:normAutofit/>
          </a:bodyPr>
          <a:lstStyle/>
          <a:p>
            <a:pPr marL="0" marR="0" indent="0" algn="just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1. The 36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Da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29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Da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band of Cho1 protein contains phosphorylated population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indent="0" algn="just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roteins were extracted from HA1 and were subjected to Lambda phosphatase treatment (NEB #P0757) before Western blotting. The phosphatase concentrations are indicated in the figure. One unit is defined as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amount of phosphatase that hydrolyzes 1 nmol of p-Nitrophenyl Phosphate in 1 min at 30°C in a total reaction volume of 50 µl. The total reaction time is 30 min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algn="just"/>
            <a:endParaRPr lang="en-US" sz="1800" dirty="0"/>
          </a:p>
        </p:txBody>
      </p:sp>
      <p:pic>
        <p:nvPicPr>
          <p:cNvPr id="4" name="Picture 3" descr="A picture containing diagram&#10;&#10;Description automatically generated">
            <a:extLst>
              <a:ext uri="{FF2B5EF4-FFF2-40B4-BE49-F238E27FC236}">
                <a16:creationId xmlns:a16="http://schemas.microsoft.com/office/drawing/2014/main" id="{4D7A3A86-361E-4B92-BDD0-A74A6F083BA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376" t="20684" b="30310"/>
          <a:stretch/>
        </p:blipFill>
        <p:spPr>
          <a:xfrm>
            <a:off x="3615558" y="2259930"/>
            <a:ext cx="4834760" cy="2107587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866D4FF5-2036-4E9E-99C4-EC816B4DFCBF}"/>
              </a:ext>
            </a:extLst>
          </p:cNvPr>
          <p:cNvSpPr/>
          <p:nvPr/>
        </p:nvSpPr>
        <p:spPr>
          <a:xfrm>
            <a:off x="2985257" y="2687151"/>
            <a:ext cx="630301" cy="2358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bulin&gt;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33005D3-E93A-4014-9743-209E5732A353}"/>
              </a:ext>
            </a:extLst>
          </p:cNvPr>
          <p:cNvSpPr/>
          <p:nvPr/>
        </p:nvSpPr>
        <p:spPr>
          <a:xfrm>
            <a:off x="3029117" y="3398351"/>
            <a:ext cx="569387" cy="2358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kDa&gt;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7ACA852-E6ED-439A-BF59-6D9F58A69C33}"/>
              </a:ext>
            </a:extLst>
          </p:cNvPr>
          <p:cNvSpPr/>
          <p:nvPr/>
        </p:nvSpPr>
        <p:spPr>
          <a:xfrm>
            <a:off x="3029117" y="3499951"/>
            <a:ext cx="569387" cy="2358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&gt;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0B43ECD-44E7-4EE8-A18C-C89568985406}"/>
              </a:ext>
            </a:extLst>
          </p:cNvPr>
          <p:cNvSpPr/>
          <p:nvPr/>
        </p:nvSpPr>
        <p:spPr>
          <a:xfrm>
            <a:off x="3029117" y="3804751"/>
            <a:ext cx="569387" cy="2358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a&gt;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232A315-951A-4CD2-A4E0-D956C2AD2FEE}"/>
              </a:ext>
            </a:extLst>
          </p:cNvPr>
          <p:cNvSpPr/>
          <p:nvPr/>
        </p:nvSpPr>
        <p:spPr>
          <a:xfrm rot="2845304">
            <a:off x="3461529" y="1792992"/>
            <a:ext cx="1317990" cy="42075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1 </a:t>
            </a:r>
          </a:p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0 unit phosphatase</a:t>
            </a:r>
            <a:endParaRPr lang="en-US" sz="93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4F995C9-CEB5-41DA-8B73-DDDE981D7870}"/>
              </a:ext>
            </a:extLst>
          </p:cNvPr>
          <p:cNvSpPr/>
          <p:nvPr/>
        </p:nvSpPr>
        <p:spPr>
          <a:xfrm rot="2938668">
            <a:off x="4124323" y="1716893"/>
            <a:ext cx="1508746" cy="42075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1 </a:t>
            </a:r>
          </a:p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800 units phosphatase</a:t>
            </a:r>
            <a:endParaRPr lang="en-US" sz="93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7CA3D42-7EA5-499D-90CC-A4DEDC8DB5FD}"/>
              </a:ext>
            </a:extLst>
          </p:cNvPr>
          <p:cNvSpPr/>
          <p:nvPr/>
        </p:nvSpPr>
        <p:spPr>
          <a:xfrm rot="2938668">
            <a:off x="5003393" y="1688447"/>
            <a:ext cx="1577676" cy="42075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1 </a:t>
            </a:r>
          </a:p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1600 units phosphatase</a:t>
            </a:r>
            <a:endParaRPr lang="en-US" sz="93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B91E93E-896F-409D-850F-4C9E9A9B6236}"/>
              </a:ext>
            </a:extLst>
          </p:cNvPr>
          <p:cNvSpPr/>
          <p:nvPr/>
        </p:nvSpPr>
        <p:spPr>
          <a:xfrm rot="2938668">
            <a:off x="6172026" y="1778381"/>
            <a:ext cx="1351652" cy="4207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67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o1∆∆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0 unit  phosphatase</a:t>
            </a:r>
            <a:endParaRPr lang="en-US" sz="93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140B00D-B27E-48A8-A28A-6DD5EDA7E505}"/>
              </a:ext>
            </a:extLst>
          </p:cNvPr>
          <p:cNvSpPr/>
          <p:nvPr/>
        </p:nvSpPr>
        <p:spPr>
          <a:xfrm rot="2938668">
            <a:off x="7064182" y="1701698"/>
            <a:ext cx="1577676" cy="42075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o1∆∆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1600 units phosphatase</a:t>
            </a:r>
            <a:endParaRPr lang="en-US" sz="93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29944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CD2435-FB68-401C-B983-48DA2A9E22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84070" y="274638"/>
            <a:ext cx="8023860" cy="868362"/>
          </a:xfrm>
        </p:spPr>
        <p:txBody>
          <a:bodyPr>
            <a:normAutofit/>
          </a:bodyPr>
          <a:lstStyle/>
          <a:p>
            <a:pPr algn="l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</a:t>
            </a:r>
          </a:p>
        </p:txBody>
      </p:sp>
      <p:sp>
        <p:nvSpPr>
          <p:cNvPr id="72" name="Content Placeholder 2">
            <a:extLst>
              <a:ext uri="{FF2B5EF4-FFF2-40B4-BE49-F238E27FC236}">
                <a16:creationId xmlns:a16="http://schemas.microsoft.com/office/drawing/2014/main" id="{577AE0AA-C806-45F7-818E-D8267CBD4C99}"/>
              </a:ext>
            </a:extLst>
          </p:cNvPr>
          <p:cNvSpPr txBox="1">
            <a:spLocks/>
          </p:cNvSpPr>
          <p:nvPr/>
        </p:nvSpPr>
        <p:spPr>
          <a:xfrm>
            <a:off x="3300325" y="3954700"/>
            <a:ext cx="4072419" cy="18329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S2. The elevated growth of L184A is not due to a spurious mutation.</a:t>
            </a: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The growth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of six L184A transformation colony candidates was measured in a spot dilution assay to rule out the possibility that a spurious mutation in the genome might account for </a:t>
            </a:r>
            <a:r>
              <a:rPr lang="en-US" sz="1200" dirty="0">
                <a:latin typeface="Times New Roman" panose="02020603050405020304" pitchFamily="18" charset="0"/>
              </a:rPr>
              <a:t>the elevated growth of  L184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(+ETA, minimal medium +1 mM ethanolamine; -ETA, minimal medium ). 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A110CBC8-5BDD-4E6B-B13E-6B79F3568708}"/>
              </a:ext>
            </a:extLst>
          </p:cNvPr>
          <p:cNvGrpSpPr/>
          <p:nvPr/>
        </p:nvGrpSpPr>
        <p:grpSpPr>
          <a:xfrm>
            <a:off x="3283234" y="414537"/>
            <a:ext cx="4089510" cy="3183457"/>
            <a:chOff x="3283234" y="414537"/>
            <a:chExt cx="4089510" cy="3183457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92C04E5E-AB45-46EE-8E6F-772B1A3A358D}"/>
                </a:ext>
              </a:extLst>
            </p:cNvPr>
            <p:cNvGrpSpPr/>
            <p:nvPr/>
          </p:nvGrpSpPr>
          <p:grpSpPr>
            <a:xfrm>
              <a:off x="3283234" y="414537"/>
              <a:ext cx="4089510" cy="3140405"/>
              <a:chOff x="2205548" y="1949423"/>
              <a:chExt cx="4089510" cy="3140405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73A325EB-82A3-4F67-A4F0-C044906B526C}"/>
                  </a:ext>
                </a:extLst>
              </p:cNvPr>
              <p:cNvGrpSpPr/>
              <p:nvPr/>
            </p:nvGrpSpPr>
            <p:grpSpPr>
              <a:xfrm>
                <a:off x="2205548" y="1949423"/>
                <a:ext cx="3454201" cy="3140405"/>
                <a:chOff x="532737" y="-828689"/>
                <a:chExt cx="5715359" cy="6256554"/>
              </a:xfrm>
            </p:grpSpPr>
            <p:grpSp>
              <p:nvGrpSpPr>
                <p:cNvPr id="9" name="Group 8">
                  <a:extLst>
                    <a:ext uri="{FF2B5EF4-FFF2-40B4-BE49-F238E27FC236}">
                      <a16:creationId xmlns:a16="http://schemas.microsoft.com/office/drawing/2014/main" id="{5BA451F0-F335-49C4-8E15-103E5A06F406}"/>
                    </a:ext>
                  </a:extLst>
                </p:cNvPr>
                <p:cNvGrpSpPr/>
                <p:nvPr/>
              </p:nvGrpSpPr>
              <p:grpSpPr>
                <a:xfrm>
                  <a:off x="542427" y="-828689"/>
                  <a:ext cx="5705669" cy="3787204"/>
                  <a:chOff x="-2481" y="-828689"/>
                  <a:chExt cx="5705669" cy="3787204"/>
                </a:xfrm>
              </p:grpSpPr>
              <p:sp>
                <p:nvSpPr>
                  <p:cNvPr id="38" name="Rectangle 37">
                    <a:extLst>
                      <a:ext uri="{FF2B5EF4-FFF2-40B4-BE49-F238E27FC236}">
                        <a16:creationId xmlns:a16="http://schemas.microsoft.com/office/drawing/2014/main" id="{229152F4-A5E6-4AAF-B375-8A8145DE2AC1}"/>
                      </a:ext>
                    </a:extLst>
                  </p:cNvPr>
                  <p:cNvSpPr/>
                  <p:nvPr/>
                </p:nvSpPr>
                <p:spPr>
                  <a:xfrm rot="18757148">
                    <a:off x="1010261" y="-45141"/>
                    <a:ext cx="961919" cy="45832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A1</a:t>
                    </a:r>
                  </a:p>
                </p:txBody>
              </p:sp>
              <p:sp>
                <p:nvSpPr>
                  <p:cNvPr id="39" name="Rectangle 38">
                    <a:extLst>
                      <a:ext uri="{FF2B5EF4-FFF2-40B4-BE49-F238E27FC236}">
                        <a16:creationId xmlns:a16="http://schemas.microsoft.com/office/drawing/2014/main" id="{4C961281-0982-4DAD-AE4C-916859043B3C}"/>
                      </a:ext>
                    </a:extLst>
                  </p:cNvPr>
                  <p:cNvSpPr/>
                  <p:nvPr/>
                </p:nvSpPr>
                <p:spPr>
                  <a:xfrm rot="18757148">
                    <a:off x="1396141" y="-215172"/>
                    <a:ext cx="1654042" cy="45832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184A (1)</a:t>
                    </a:r>
                  </a:p>
                </p:txBody>
              </p:sp>
              <p:sp>
                <p:nvSpPr>
                  <p:cNvPr id="40" name="Rectangle 39">
                    <a:extLst>
                      <a:ext uri="{FF2B5EF4-FFF2-40B4-BE49-F238E27FC236}">
                        <a16:creationId xmlns:a16="http://schemas.microsoft.com/office/drawing/2014/main" id="{C9A0BB27-0297-4F0A-AF71-0A0CA639214B}"/>
                      </a:ext>
                    </a:extLst>
                  </p:cNvPr>
                  <p:cNvSpPr/>
                  <p:nvPr/>
                </p:nvSpPr>
                <p:spPr>
                  <a:xfrm rot="18757148">
                    <a:off x="1935304" y="-198150"/>
                    <a:ext cx="1654042" cy="45832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184A (2)</a:t>
                    </a:r>
                  </a:p>
                </p:txBody>
              </p:sp>
              <p:sp>
                <p:nvSpPr>
                  <p:cNvPr id="41" name="Rectangle 40">
                    <a:extLst>
                      <a:ext uri="{FF2B5EF4-FFF2-40B4-BE49-F238E27FC236}">
                        <a16:creationId xmlns:a16="http://schemas.microsoft.com/office/drawing/2014/main" id="{D1D027D6-7900-4D2C-AE75-3DF90B295350}"/>
                      </a:ext>
                    </a:extLst>
                  </p:cNvPr>
                  <p:cNvSpPr/>
                  <p:nvPr/>
                </p:nvSpPr>
                <p:spPr>
                  <a:xfrm rot="18757148">
                    <a:off x="2522216" y="-212161"/>
                    <a:ext cx="1654042" cy="45832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184A (3)</a:t>
                    </a:r>
                  </a:p>
                </p:txBody>
              </p:sp>
              <p:sp>
                <p:nvSpPr>
                  <p:cNvPr id="43" name="Rectangle 42">
                    <a:extLst>
                      <a:ext uri="{FF2B5EF4-FFF2-40B4-BE49-F238E27FC236}">
                        <a16:creationId xmlns:a16="http://schemas.microsoft.com/office/drawing/2014/main" id="{D1EBE840-051B-452E-A56D-334794EC2EBA}"/>
                      </a:ext>
                    </a:extLst>
                  </p:cNvPr>
                  <p:cNvSpPr/>
                  <p:nvPr/>
                </p:nvSpPr>
                <p:spPr>
                  <a:xfrm rot="18757148">
                    <a:off x="3081915" y="-212161"/>
                    <a:ext cx="1654042" cy="45832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184A (4)</a:t>
                    </a:r>
                  </a:p>
                </p:txBody>
              </p:sp>
              <p:sp>
                <p:nvSpPr>
                  <p:cNvPr id="44" name="Rectangle 43">
                    <a:extLst>
                      <a:ext uri="{FF2B5EF4-FFF2-40B4-BE49-F238E27FC236}">
                        <a16:creationId xmlns:a16="http://schemas.microsoft.com/office/drawing/2014/main" id="{7E68F3BF-DEDD-4AFB-A294-E2445B10D4CE}"/>
                      </a:ext>
                    </a:extLst>
                  </p:cNvPr>
                  <p:cNvSpPr/>
                  <p:nvPr/>
                </p:nvSpPr>
                <p:spPr>
                  <a:xfrm rot="18757148">
                    <a:off x="3771437" y="-253941"/>
                    <a:ext cx="1654042" cy="76387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184A (5)</a:t>
                    </a:r>
                  </a:p>
                  <a:p>
                    <a:endPara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5" name="Rectangle 44">
                    <a:extLst>
                      <a:ext uri="{FF2B5EF4-FFF2-40B4-BE49-F238E27FC236}">
                        <a16:creationId xmlns:a16="http://schemas.microsoft.com/office/drawing/2014/main" id="{58BE9462-CE16-43AD-B07F-7282CE6F7BA7}"/>
                      </a:ext>
                    </a:extLst>
                  </p:cNvPr>
                  <p:cNvSpPr/>
                  <p:nvPr/>
                </p:nvSpPr>
                <p:spPr>
                  <a:xfrm rot="18757148">
                    <a:off x="4195211" y="-230831"/>
                    <a:ext cx="1654042" cy="45832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184A (6)</a:t>
                    </a:r>
                  </a:p>
                </p:txBody>
              </p:sp>
              <p:sp>
                <p:nvSpPr>
                  <p:cNvPr id="47" name="Rectangle 46">
                    <a:extLst>
                      <a:ext uri="{FF2B5EF4-FFF2-40B4-BE49-F238E27FC236}">
                        <a16:creationId xmlns:a16="http://schemas.microsoft.com/office/drawing/2014/main" id="{36ED1154-BE38-40A6-97E0-7D2E40D45380}"/>
                      </a:ext>
                    </a:extLst>
                  </p:cNvPr>
                  <p:cNvSpPr/>
                  <p:nvPr/>
                </p:nvSpPr>
                <p:spPr>
                  <a:xfrm rot="18757148">
                    <a:off x="4793463" y="-114119"/>
                    <a:ext cx="1361123" cy="45832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ho1</a:t>
                    </a:r>
                    <a:r>
                      <a:rPr lang="el-GR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ΔΔ</a:t>
                    </a:r>
                    <a:endPara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8" name="Rectangle 47">
                    <a:extLst>
                      <a:ext uri="{FF2B5EF4-FFF2-40B4-BE49-F238E27FC236}">
                        <a16:creationId xmlns:a16="http://schemas.microsoft.com/office/drawing/2014/main" id="{EB8B020B-13DF-4D3A-9E55-5DD7780B09A9}"/>
                      </a:ext>
                    </a:extLst>
                  </p:cNvPr>
                  <p:cNvSpPr/>
                  <p:nvPr/>
                </p:nvSpPr>
                <p:spPr>
                  <a:xfrm>
                    <a:off x="-2481" y="675269"/>
                    <a:ext cx="1053512" cy="55185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D 0.1</a:t>
                    </a:r>
                  </a:p>
                </p:txBody>
              </p:sp>
              <p:sp>
                <p:nvSpPr>
                  <p:cNvPr id="49" name="Rectangle 48">
                    <a:extLst>
                      <a:ext uri="{FF2B5EF4-FFF2-40B4-BE49-F238E27FC236}">
                        <a16:creationId xmlns:a16="http://schemas.microsoft.com/office/drawing/2014/main" id="{44328077-5D41-4186-A760-BE12F797A287}"/>
                      </a:ext>
                    </a:extLst>
                  </p:cNvPr>
                  <p:cNvSpPr/>
                  <p:nvPr/>
                </p:nvSpPr>
                <p:spPr>
                  <a:xfrm>
                    <a:off x="464382" y="1245699"/>
                    <a:ext cx="573439" cy="55185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</a:t>
                    </a:r>
                    <a:r>
                      <a:rPr lang="en-US" sz="12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1</a:t>
                    </a:r>
                  </a:p>
                </p:txBody>
              </p:sp>
              <p:sp>
                <p:nvSpPr>
                  <p:cNvPr id="50" name="Rectangle 49">
                    <a:extLst>
                      <a:ext uri="{FF2B5EF4-FFF2-40B4-BE49-F238E27FC236}">
                        <a16:creationId xmlns:a16="http://schemas.microsoft.com/office/drawing/2014/main" id="{16D22F9E-8504-40F6-8F8C-BAA3F932B1B7}"/>
                      </a:ext>
                    </a:extLst>
                  </p:cNvPr>
                  <p:cNvSpPr/>
                  <p:nvPr/>
                </p:nvSpPr>
                <p:spPr>
                  <a:xfrm>
                    <a:off x="457201" y="1821243"/>
                    <a:ext cx="573438" cy="55185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</a:t>
                    </a:r>
                    <a:r>
                      <a:rPr lang="en-US" sz="12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2</a:t>
                    </a:r>
                  </a:p>
                </p:txBody>
              </p:sp>
              <p:sp>
                <p:nvSpPr>
                  <p:cNvPr id="51" name="Rectangle 50">
                    <a:extLst>
                      <a:ext uri="{FF2B5EF4-FFF2-40B4-BE49-F238E27FC236}">
                        <a16:creationId xmlns:a16="http://schemas.microsoft.com/office/drawing/2014/main" id="{F3DF2F61-0ED3-4151-BDFE-CC34FC51CCE1}"/>
                      </a:ext>
                    </a:extLst>
                  </p:cNvPr>
                  <p:cNvSpPr/>
                  <p:nvPr/>
                </p:nvSpPr>
                <p:spPr>
                  <a:xfrm>
                    <a:off x="457201" y="2406656"/>
                    <a:ext cx="573439" cy="55185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</a:t>
                    </a:r>
                    <a:r>
                      <a:rPr lang="en-US" sz="12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3</a:t>
                    </a:r>
                  </a:p>
                </p:txBody>
              </p:sp>
            </p:grpSp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EFF4615C-3A14-4753-BC2E-41BE5FB87AC7}"/>
                    </a:ext>
                  </a:extLst>
                </p:cNvPr>
                <p:cNvGrpSpPr/>
                <p:nvPr/>
              </p:nvGrpSpPr>
              <p:grpSpPr>
                <a:xfrm>
                  <a:off x="532737" y="3113210"/>
                  <a:ext cx="1053512" cy="2314655"/>
                  <a:chOff x="532737" y="3113210"/>
                  <a:chExt cx="1053512" cy="2314655"/>
                </a:xfrm>
              </p:grpSpPr>
              <p:sp>
                <p:nvSpPr>
                  <p:cNvPr id="12" name="Rectangle 11">
                    <a:extLst>
                      <a:ext uri="{FF2B5EF4-FFF2-40B4-BE49-F238E27FC236}">
                        <a16:creationId xmlns:a16="http://schemas.microsoft.com/office/drawing/2014/main" id="{8976CEAE-7CFB-4DA3-A1C3-99D7F8E19B00}"/>
                      </a:ext>
                    </a:extLst>
                  </p:cNvPr>
                  <p:cNvSpPr/>
                  <p:nvPr/>
                </p:nvSpPr>
                <p:spPr>
                  <a:xfrm>
                    <a:off x="532737" y="3113210"/>
                    <a:ext cx="1053512" cy="55185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D 0.1</a:t>
                    </a:r>
                  </a:p>
                </p:txBody>
              </p:sp>
              <p:sp>
                <p:nvSpPr>
                  <p:cNvPr id="13" name="Rectangle 12">
                    <a:extLst>
                      <a:ext uri="{FF2B5EF4-FFF2-40B4-BE49-F238E27FC236}">
                        <a16:creationId xmlns:a16="http://schemas.microsoft.com/office/drawing/2014/main" id="{C25D55AF-EE0D-4C19-A61D-F363EEC167D7}"/>
                      </a:ext>
                    </a:extLst>
                  </p:cNvPr>
                  <p:cNvSpPr/>
                  <p:nvPr/>
                </p:nvSpPr>
                <p:spPr>
                  <a:xfrm>
                    <a:off x="997363" y="3683987"/>
                    <a:ext cx="573438" cy="55185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</a:t>
                    </a:r>
                    <a:r>
                      <a:rPr lang="en-US" sz="12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1</a:t>
                    </a:r>
                  </a:p>
                </p:txBody>
              </p:sp>
              <p:sp>
                <p:nvSpPr>
                  <p:cNvPr id="14" name="Rectangle 13">
                    <a:extLst>
                      <a:ext uri="{FF2B5EF4-FFF2-40B4-BE49-F238E27FC236}">
                        <a16:creationId xmlns:a16="http://schemas.microsoft.com/office/drawing/2014/main" id="{E9E4A771-97AA-4517-8516-B28815640B83}"/>
                      </a:ext>
                    </a:extLst>
                  </p:cNvPr>
                  <p:cNvSpPr/>
                  <p:nvPr/>
                </p:nvSpPr>
                <p:spPr>
                  <a:xfrm>
                    <a:off x="972795" y="4307029"/>
                    <a:ext cx="573438" cy="55185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</a:t>
                    </a:r>
                    <a:r>
                      <a:rPr lang="en-US" sz="12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2</a:t>
                    </a:r>
                  </a:p>
                </p:txBody>
              </p:sp>
              <p:sp>
                <p:nvSpPr>
                  <p:cNvPr id="15" name="Rectangle 14">
                    <a:extLst>
                      <a:ext uri="{FF2B5EF4-FFF2-40B4-BE49-F238E27FC236}">
                        <a16:creationId xmlns:a16="http://schemas.microsoft.com/office/drawing/2014/main" id="{072B244C-B8FA-4BEF-B9EE-4E202D918692}"/>
                      </a:ext>
                    </a:extLst>
                  </p:cNvPr>
                  <p:cNvSpPr/>
                  <p:nvPr/>
                </p:nvSpPr>
                <p:spPr>
                  <a:xfrm>
                    <a:off x="972795" y="4876007"/>
                    <a:ext cx="573438" cy="55185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</a:t>
                    </a:r>
                    <a:r>
                      <a:rPr lang="en-US" sz="12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3</a:t>
                    </a:r>
                  </a:p>
                </p:txBody>
              </p:sp>
            </p:grpSp>
          </p:grpSp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14505BE4-72F0-441D-A544-C01E5087A8F9}"/>
                  </a:ext>
                </a:extLst>
              </p:cNvPr>
              <p:cNvSpPr/>
              <p:nvPr/>
            </p:nvSpPr>
            <p:spPr>
              <a:xfrm>
                <a:off x="5616756" y="3067343"/>
                <a:ext cx="64581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 ETA</a:t>
                </a:r>
              </a:p>
            </p:txBody>
          </p:sp>
          <p:sp>
            <p:nvSpPr>
              <p:cNvPr id="71" name="Rectangle 70">
                <a:extLst>
                  <a:ext uri="{FF2B5EF4-FFF2-40B4-BE49-F238E27FC236}">
                    <a16:creationId xmlns:a16="http://schemas.microsoft.com/office/drawing/2014/main" id="{C2447215-B399-4BA4-9C7E-E3EF17750CA4}"/>
                  </a:ext>
                </a:extLst>
              </p:cNvPr>
              <p:cNvSpPr/>
              <p:nvPr/>
            </p:nvSpPr>
            <p:spPr>
              <a:xfrm>
                <a:off x="5605959" y="4322229"/>
                <a:ext cx="689099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 ETA</a:t>
                </a:r>
              </a:p>
            </p:txBody>
          </p:sp>
        </p:grp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2D459BBA-6A48-4D14-A36C-D8F113D41B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3411" t="21712" r="15767" b="1398"/>
            <a:stretch/>
          </p:blipFill>
          <p:spPr>
            <a:xfrm>
              <a:off x="3868670" y="1136985"/>
              <a:ext cx="2884212" cy="246100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645593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4525FE-7C08-45A5-8214-C1494CDE8D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A3A3B9F-081D-4C3E-87C6-5C4F35822DCC}"/>
              </a:ext>
            </a:extLst>
          </p:cNvPr>
          <p:cNvSpPr txBox="1"/>
          <p:nvPr/>
        </p:nvSpPr>
        <p:spPr>
          <a:xfrm>
            <a:off x="1515793" y="2743239"/>
            <a:ext cx="6245721" cy="19697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o1	D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25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X)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28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29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X)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2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3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X)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42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X)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46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X)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en-US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pt1	D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X)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13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14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X)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17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18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X)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27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X)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1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X)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5</a:t>
            </a:r>
            <a:endParaRPr lang="en-US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Alignment of CAPT motifs from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. cerevisiae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pt1 and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. albicans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ho1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ignment of CAPT motifs from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. cerevisiae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pt1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. albicans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ho1 demonstrates the conserved nature of the amino acids within this proposed CDP-alcohol binding domain.</a:t>
            </a:r>
          </a:p>
        </p:txBody>
      </p:sp>
    </p:spTree>
    <p:extLst>
      <p:ext uri="{BB962C8B-B14F-4D97-AF65-F5344CB8AC3E}">
        <p14:creationId xmlns:p14="http://schemas.microsoft.com/office/powerpoint/2010/main" val="22976381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74F41BE2-2BC2-4E70-8462-C99E6756C873}"/>
              </a:ext>
            </a:extLst>
          </p:cNvPr>
          <p:cNvGrpSpPr/>
          <p:nvPr/>
        </p:nvGrpSpPr>
        <p:grpSpPr>
          <a:xfrm>
            <a:off x="2022865" y="1199540"/>
            <a:ext cx="9849095" cy="2936362"/>
            <a:chOff x="2022865" y="1199540"/>
            <a:chExt cx="9849095" cy="2936362"/>
          </a:xfrm>
        </p:grpSpPr>
        <p:pic>
          <p:nvPicPr>
            <p:cNvPr id="13" name="Picture 12" descr="A picture containing text, newspaper, document&#10;&#10;Description automatically generated">
              <a:extLst>
                <a:ext uri="{FF2B5EF4-FFF2-40B4-BE49-F238E27FC236}">
                  <a16:creationId xmlns:a16="http://schemas.microsoft.com/office/drawing/2014/main" id="{84490DA1-F4D2-460F-B48C-E6F8845D96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618"/>
            <a:stretch/>
          </p:blipFill>
          <p:spPr>
            <a:xfrm>
              <a:off x="2022865" y="1199540"/>
              <a:ext cx="9849095" cy="2936362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78CE96C9-93A4-4AE4-AA60-24843F1BC151}"/>
                </a:ext>
              </a:extLst>
            </p:cNvPr>
            <p:cNvSpPr/>
            <p:nvPr/>
          </p:nvSpPr>
          <p:spPr>
            <a:xfrm>
              <a:off x="7802139" y="1225666"/>
              <a:ext cx="675651" cy="2862959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E6516F2B-CFA7-4A84-809C-9E4589EF9A11}"/>
                </a:ext>
              </a:extLst>
            </p:cNvPr>
            <p:cNvCxnSpPr>
              <a:cxnSpLocks/>
            </p:cNvCxnSpPr>
            <p:nvPr/>
          </p:nvCxnSpPr>
          <p:spPr>
            <a:xfrm>
              <a:off x="7032819" y="1403305"/>
              <a:ext cx="1170432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" name="Title 1">
            <a:extLst>
              <a:ext uri="{FF2B5EF4-FFF2-40B4-BE49-F238E27FC236}">
                <a16:creationId xmlns:a16="http://schemas.microsoft.com/office/drawing/2014/main" id="{E8AE5373-6FFC-4569-97EC-9994763088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</a:p>
        </p:txBody>
      </p:sp>
      <p:sp>
        <p:nvSpPr>
          <p:cNvPr id="3" name="Right Brace 2">
            <a:extLst>
              <a:ext uri="{FF2B5EF4-FFF2-40B4-BE49-F238E27FC236}">
                <a16:creationId xmlns:a16="http://schemas.microsoft.com/office/drawing/2014/main" id="{EF6B6069-90E7-49E2-A179-FBBE9FEA6C1C}"/>
              </a:ext>
            </a:extLst>
          </p:cNvPr>
          <p:cNvSpPr/>
          <p:nvPr/>
        </p:nvSpPr>
        <p:spPr>
          <a:xfrm rot="10800000">
            <a:off x="1977145" y="1240870"/>
            <a:ext cx="45719" cy="1539221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92850E0-810A-4536-B0F2-1ED4FD178A38}"/>
              </a:ext>
            </a:extLst>
          </p:cNvPr>
          <p:cNvSpPr txBox="1"/>
          <p:nvPr/>
        </p:nvSpPr>
        <p:spPr>
          <a:xfrm>
            <a:off x="465791" y="1849455"/>
            <a:ext cx="18358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S synthases</a:t>
            </a:r>
            <a:endParaRPr lang="en-US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A23DD4A-130E-4D82-921A-11B41E281C43}"/>
              </a:ext>
            </a:extLst>
          </p:cNvPr>
          <p:cNvSpPr txBox="1"/>
          <p:nvPr/>
        </p:nvSpPr>
        <p:spPr>
          <a:xfrm>
            <a:off x="494974" y="3243006"/>
            <a:ext cx="18358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I synthases</a:t>
            </a:r>
            <a:endParaRPr lang="en-US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0C5CB11-CDC6-473C-BC9E-5DCB41E26748}"/>
              </a:ext>
            </a:extLst>
          </p:cNvPr>
          <p:cNvSpPr txBox="1"/>
          <p:nvPr/>
        </p:nvSpPr>
        <p:spPr>
          <a:xfrm>
            <a:off x="1073331" y="4465941"/>
            <a:ext cx="1048136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4. Alignment of several previously reviewed PS synthase with PI synthase sequences from different species reveals part of the putative serine binding site in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. albicans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o1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 further alignment of 8 previously reviewed PS synthases with 7 previously reviewed PI synthase sequences from different species, in the presence of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. albicans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ho1, has generated a region in all PS synthases which is absent in all PI synthases (red box). The putative serine binding of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. albicans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ho1 is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underlined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</p:txBody>
      </p:sp>
      <p:sp>
        <p:nvSpPr>
          <p:cNvPr id="17" name="Right Brace 16">
            <a:extLst>
              <a:ext uri="{FF2B5EF4-FFF2-40B4-BE49-F238E27FC236}">
                <a16:creationId xmlns:a16="http://schemas.microsoft.com/office/drawing/2014/main" id="{D2DFB38E-804F-4940-A6A0-4C9475126D5E}"/>
              </a:ext>
            </a:extLst>
          </p:cNvPr>
          <p:cNvSpPr/>
          <p:nvPr/>
        </p:nvSpPr>
        <p:spPr>
          <a:xfrm rot="10800000">
            <a:off x="1977144" y="2860608"/>
            <a:ext cx="45720" cy="1191175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4547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38</TotalTime>
  <Words>659</Words>
  <Application>Microsoft Office PowerPoint</Application>
  <PresentationFormat>Widescreen</PresentationFormat>
  <Paragraphs>144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Table S1. Normalized densitometry values (NDVs) via western blotting for CAPT motif (left) and serine binding motif (right) mutants</vt:lpstr>
      <vt:lpstr>S1</vt:lpstr>
      <vt:lpstr>S2.</vt:lpstr>
      <vt:lpstr>S3.</vt:lpstr>
      <vt:lpstr>S4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, Yue</dc:creator>
  <cp:lastModifiedBy>Zhou, Yue</cp:lastModifiedBy>
  <cp:revision>73</cp:revision>
  <dcterms:created xsi:type="dcterms:W3CDTF">2020-09-30T21:33:07Z</dcterms:created>
  <dcterms:modified xsi:type="dcterms:W3CDTF">2021-12-08T05:18:14Z</dcterms:modified>
</cp:coreProperties>
</file>